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416" r:id="rId2"/>
    <p:sldId id="420" r:id="rId3"/>
    <p:sldId id="414" r:id="rId4"/>
    <p:sldId id="417" r:id="rId5"/>
    <p:sldId id="418" r:id="rId6"/>
    <p:sldId id="256" r:id="rId7"/>
    <p:sldId id="260" r:id="rId8"/>
    <p:sldId id="421" r:id="rId9"/>
    <p:sldId id="413" r:id="rId10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97" autoAdjust="0"/>
    <p:restoredTop sz="94660"/>
  </p:normalViewPr>
  <p:slideViewPr>
    <p:cSldViewPr snapToGrid="0">
      <p:cViewPr varScale="1">
        <p:scale>
          <a:sx n="109" d="100"/>
          <a:sy n="109" d="100"/>
        </p:scale>
        <p:origin x="104" y="51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10" d="100"/>
        <a:sy n="11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BF04473-20BD-86DD-44CE-47846815B4C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4CBFDBA-DDCB-D3BC-E2C3-ED9BCD6799D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B6890C4-030F-7A12-E0FD-AFA3352D00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8A2670-8B8C-4835-8E73-0F9E733C156B}" type="datetimeFigureOut">
              <a:rPr lang="en-US" smtClean="0"/>
              <a:t>4/1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2F2FB3F-6AC7-5F77-230E-33B738A3C6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79368D5-B7A4-4748-715A-54E924B134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BD9B7-3BC5-438D-B73A-369091C76B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33962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FE5ACF-6705-4C6C-5F7D-EB1A95031EF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05A40F9-40A9-7BF2-4F6F-65B544E0BB1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44EDA95-74BC-EA07-29F7-0A24D0F34D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8A2670-8B8C-4835-8E73-0F9E733C156B}" type="datetimeFigureOut">
              <a:rPr lang="en-US" smtClean="0"/>
              <a:t>4/1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1F51C91-A519-7679-A16B-663F5172AE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C9A2E9B-E152-7466-45C5-09B90147FB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BD9B7-3BC5-438D-B73A-369091C76B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87510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E85D13F-0DDD-31D7-3FB2-C95A5AB5FEA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BD21591-3F17-3E87-BBF1-7863FC1598D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2D9B7E4-12E6-0F12-BC3B-82EE2672A2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8A2670-8B8C-4835-8E73-0F9E733C156B}" type="datetimeFigureOut">
              <a:rPr lang="en-US" smtClean="0"/>
              <a:t>4/1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1A9F582-050F-41DC-D93F-C7E79CACD5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A65392B-CE48-C365-B9FB-58A79D15C6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BD9B7-3BC5-438D-B73A-369091C76B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74746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6AD062-37C3-1943-2F9A-59DE0EDD4B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972E7AC-151F-BD9E-B6D9-CD43C854CCA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2E91F1D-C85C-E8A4-9E19-8754F60918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8A2670-8B8C-4835-8E73-0F9E733C156B}" type="datetimeFigureOut">
              <a:rPr lang="en-US" smtClean="0"/>
              <a:t>4/1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0496FD3-DD4E-2662-E92C-8F0402CCE3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37AAE24-A634-75A1-1D91-E3337427F4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BD9B7-3BC5-438D-B73A-369091C76B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68581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7416E0-E11F-904D-C19B-7E86F3379A8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D00921A-C9E3-51DF-A394-2062BE4E3EE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2950167-D6E5-80F0-D779-25E52B9F98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8A2670-8B8C-4835-8E73-0F9E733C156B}" type="datetimeFigureOut">
              <a:rPr lang="en-US" smtClean="0"/>
              <a:t>4/1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77FB5A2-12CF-94E0-94A6-D268E854AE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8C1B00C-812A-E5C4-E081-61588256DC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BD9B7-3BC5-438D-B73A-369091C76B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85473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8DC025-E3D0-AF47-A533-3FBB32C78D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7E552AE-8455-FAE9-85A4-C496F4B8A99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9397DB8-A6F0-8C50-222C-ACDEA27DD48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894AE8A-CE92-FBF1-A65D-754DFEDAD7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8A2670-8B8C-4835-8E73-0F9E733C156B}" type="datetimeFigureOut">
              <a:rPr lang="en-US" smtClean="0"/>
              <a:t>4/17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162429F-9E83-BDC5-6655-16AE9902EA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8139EC6-3667-198B-CE86-E90201245B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BD9B7-3BC5-438D-B73A-369091C76B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54371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B41DFA-AC69-FA39-8463-0F0E704DB8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BFDFEBE-3F9C-B051-AADA-3B23395CBBD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F38C99A-9A7A-5191-40DD-301263EA6B5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920D152-880D-6EF8-0664-53EA39ABB4D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40BACC1-E03C-672C-8E3B-7613BBED5F6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8A89AF6-7225-59F3-49F3-86225CA56F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8A2670-8B8C-4835-8E73-0F9E733C156B}" type="datetimeFigureOut">
              <a:rPr lang="en-US" smtClean="0"/>
              <a:t>4/17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6EEFA90-E060-37A0-A651-F03C4BA180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13B1659-342C-BCF0-4CB8-65791942FA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BD9B7-3BC5-438D-B73A-369091C76B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50928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D2BB7E3-A782-8639-AE8E-B5456A6BBB7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365D02C-4CF0-8C0F-202E-399FDDF0FF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8A2670-8B8C-4835-8E73-0F9E733C156B}" type="datetimeFigureOut">
              <a:rPr lang="en-US" smtClean="0"/>
              <a:t>4/17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2E31AED-4A4D-9929-9708-C19018D0D3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39BD18A-4679-A47A-C54A-33E07FDA79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BD9B7-3BC5-438D-B73A-369091C76B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42109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284C19F-1E29-D743-7040-6E38C321C0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8A2670-8B8C-4835-8E73-0F9E733C156B}" type="datetimeFigureOut">
              <a:rPr lang="en-US" smtClean="0"/>
              <a:t>4/17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A3423CD-73AB-9A05-2B5C-FBD31F3409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FBC71B9-04F1-02FE-DC36-3FD3D8EE4E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BD9B7-3BC5-438D-B73A-369091C76B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22625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DAE6579-DEA7-B25F-A2B3-E796AE19A6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5C92F22-00E1-42DD-5C0C-60118BEC653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235421C-08EA-DA6F-23A5-1F992CDA815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0748D46-46C8-007E-CF18-9BD294A3D5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8A2670-8B8C-4835-8E73-0F9E733C156B}" type="datetimeFigureOut">
              <a:rPr lang="en-US" smtClean="0"/>
              <a:t>4/17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9F7C34A-8D85-6EDF-8487-8D1FF8D4AB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582B33B-6802-5344-0DCD-A7775FC975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BD9B7-3BC5-438D-B73A-369091C76B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02609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D63F3B-6304-924D-F94C-910394DAFA0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8FE6FEF-4D70-B234-CC6A-102E70AEEBE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8AAB70C-8F52-F323-789F-10801311527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D756071-48E5-8FA1-1F8F-D513A01DA7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8A2670-8B8C-4835-8E73-0F9E733C156B}" type="datetimeFigureOut">
              <a:rPr lang="en-US" smtClean="0"/>
              <a:t>4/17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F70D256-A1AF-B900-D78C-CCA6C32194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DCBC9E7-B4BC-3BE4-7991-1EB07F7C36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BD9B7-3BC5-438D-B73A-369091C76B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34434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F16BE64-D10B-C28E-F8C2-B6F2182A129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957C163-AD72-83A7-C7C9-5C2DB4438CD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CCE6B75-4723-79EC-6544-48C669EC805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8A2670-8B8C-4835-8E73-0F9E733C156B}" type="datetimeFigureOut">
              <a:rPr lang="en-US" smtClean="0"/>
              <a:t>4/1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62C1892-0EAD-17D8-24EC-1282FA9F001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76A0C8A-6F17-EA08-0286-CE604BF4414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EBD9B7-3BC5-438D-B73A-369091C76B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52303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7" Type="http://schemas.openxmlformats.org/officeDocument/2006/relationships/image" Target="../media/image5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1.xml"/><Relationship Id="rId6" Type="http://schemas.openxmlformats.org/officeDocument/2006/relationships/oleObject" Target="../embeddings/oleObject3.bin"/><Relationship Id="rId5" Type="http://schemas.openxmlformats.org/officeDocument/2006/relationships/image" Target="../media/image4.emf"/><Relationship Id="rId4" Type="http://schemas.openxmlformats.org/officeDocument/2006/relationships/oleObject" Target="../embeddings/oleObject2.bin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7.bin"/><Relationship Id="rId3" Type="http://schemas.openxmlformats.org/officeDocument/2006/relationships/image" Target="../media/image6.emf"/><Relationship Id="rId7" Type="http://schemas.openxmlformats.org/officeDocument/2006/relationships/image" Target="../media/image8.emf"/><Relationship Id="rId2" Type="http://schemas.openxmlformats.org/officeDocument/2006/relationships/oleObject" Target="../embeddings/oleObject4.bin"/><Relationship Id="rId1" Type="http://schemas.openxmlformats.org/officeDocument/2006/relationships/slideLayout" Target="../slideLayouts/slideLayout1.xml"/><Relationship Id="rId6" Type="http://schemas.openxmlformats.org/officeDocument/2006/relationships/oleObject" Target="../embeddings/oleObject6.bin"/><Relationship Id="rId5" Type="http://schemas.openxmlformats.org/officeDocument/2006/relationships/image" Target="../media/image7.emf"/><Relationship Id="rId4" Type="http://schemas.openxmlformats.org/officeDocument/2006/relationships/oleObject" Target="../embeddings/oleObject5.bin"/><Relationship Id="rId9" Type="http://schemas.openxmlformats.org/officeDocument/2006/relationships/image" Target="../media/image9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oleObject" Target="../embeddings/oleObject8.bin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1.emf"/><Relationship Id="rId4" Type="http://schemas.openxmlformats.org/officeDocument/2006/relationships/oleObject" Target="../embeddings/oleObject9.bin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emf"/><Relationship Id="rId2" Type="http://schemas.openxmlformats.org/officeDocument/2006/relationships/oleObject" Target="../embeddings/oleObject10.bin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3.emf"/><Relationship Id="rId4" Type="http://schemas.openxmlformats.org/officeDocument/2006/relationships/oleObject" Target="../embeddings/oleObject11.bin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5.bin"/><Relationship Id="rId13" Type="http://schemas.openxmlformats.org/officeDocument/2006/relationships/image" Target="../media/image19.wmf"/><Relationship Id="rId3" Type="http://schemas.openxmlformats.org/officeDocument/2006/relationships/image" Target="../media/image14.wmf"/><Relationship Id="rId7" Type="http://schemas.openxmlformats.org/officeDocument/2006/relationships/image" Target="../media/image16.wmf"/><Relationship Id="rId12" Type="http://schemas.openxmlformats.org/officeDocument/2006/relationships/oleObject" Target="../embeddings/oleObject17.bin"/><Relationship Id="rId2" Type="http://schemas.openxmlformats.org/officeDocument/2006/relationships/oleObject" Target="../embeddings/oleObject12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14.bin"/><Relationship Id="rId11" Type="http://schemas.openxmlformats.org/officeDocument/2006/relationships/image" Target="../media/image18.wmf"/><Relationship Id="rId5" Type="http://schemas.openxmlformats.org/officeDocument/2006/relationships/image" Target="../media/image15.wmf"/><Relationship Id="rId10" Type="http://schemas.openxmlformats.org/officeDocument/2006/relationships/oleObject" Target="../embeddings/oleObject16.bin"/><Relationship Id="rId4" Type="http://schemas.openxmlformats.org/officeDocument/2006/relationships/oleObject" Target="../embeddings/oleObject13.bin"/><Relationship Id="rId9" Type="http://schemas.openxmlformats.org/officeDocument/2006/relationships/image" Target="../media/image17.wmf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30504F8-7409-5D89-262D-AE1C2C735C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47071" y="2157855"/>
            <a:ext cx="10515600" cy="1459988"/>
          </a:xfrm>
        </p:spPr>
        <p:txBody>
          <a:bodyPr>
            <a:normAutofit/>
          </a:bodyPr>
          <a:lstStyle/>
          <a:p>
            <a:pPr algn="ctr"/>
            <a:r>
              <a:rPr lang="en-US" sz="4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Materials</a:t>
            </a:r>
          </a:p>
        </p:txBody>
      </p:sp>
    </p:spTree>
    <p:extLst>
      <p:ext uri="{BB962C8B-B14F-4D97-AF65-F5344CB8AC3E}">
        <p14:creationId xmlns:p14="http://schemas.microsoft.com/office/powerpoint/2010/main" val="179084808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>
            <a:extLst>
              <a:ext uri="{FF2B5EF4-FFF2-40B4-BE49-F238E27FC236}">
                <a16:creationId xmlns:a16="http://schemas.microsoft.com/office/drawing/2014/main" id="{FB138889-9F3E-CF67-1917-DCA610B61B2F}"/>
              </a:ext>
            </a:extLst>
          </p:cNvPr>
          <p:cNvGrpSpPr/>
          <p:nvPr/>
        </p:nvGrpSpPr>
        <p:grpSpPr>
          <a:xfrm>
            <a:off x="693148" y="1099574"/>
            <a:ext cx="5461925" cy="4890052"/>
            <a:chOff x="1245470" y="1216175"/>
            <a:chExt cx="5461925" cy="4890052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DD92D982-9C2B-CD57-4900-8F8E9901F1D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274082" y="1216175"/>
              <a:ext cx="5433313" cy="4007789"/>
            </a:xfrm>
            <a:prstGeom prst="rect">
              <a:avLst/>
            </a:prstGeom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181339F6-0800-4163-7869-055F75CC1AA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b="86889"/>
            <a:stretch/>
          </p:blipFill>
          <p:spPr>
            <a:xfrm>
              <a:off x="1245470" y="5554964"/>
              <a:ext cx="5433313" cy="551263"/>
            </a:xfrm>
            <a:prstGeom prst="rect">
              <a:avLst/>
            </a:prstGeom>
          </p:spPr>
        </p:pic>
      </p:grpSp>
      <p:pic>
        <p:nvPicPr>
          <p:cNvPr id="6" name="Picture 5">
            <a:extLst>
              <a:ext uri="{FF2B5EF4-FFF2-40B4-BE49-F238E27FC236}">
                <a16:creationId xmlns:a16="http://schemas.microsoft.com/office/drawing/2014/main" id="{B04069AF-F9C1-5228-2639-80822576EEEC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13466"/>
          <a:stretch/>
        </p:blipFill>
        <p:spPr>
          <a:xfrm>
            <a:off x="6529675" y="1029530"/>
            <a:ext cx="5521176" cy="3697239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2452F508-2709-94D5-FF64-39AB57F3B9EC}"/>
              </a:ext>
            </a:extLst>
          </p:cNvPr>
          <p:cNvSpPr txBox="1"/>
          <p:nvPr/>
        </p:nvSpPr>
        <p:spPr>
          <a:xfrm>
            <a:off x="506604" y="248428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S1</a:t>
            </a:r>
          </a:p>
        </p:txBody>
      </p:sp>
    </p:spTree>
    <p:extLst>
      <p:ext uri="{BB962C8B-B14F-4D97-AF65-F5344CB8AC3E}">
        <p14:creationId xmlns:p14="http://schemas.microsoft.com/office/powerpoint/2010/main" val="327383635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8FDFABA9-8F17-346D-DE48-6008DEA5E75C}"/>
              </a:ext>
            </a:extLst>
          </p:cNvPr>
          <p:cNvSpPr txBox="1"/>
          <p:nvPr/>
        </p:nvSpPr>
        <p:spPr>
          <a:xfrm>
            <a:off x="653890" y="469357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S2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F3D2422D-6617-02AB-E2A3-E808592BED7C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366618" y="1611647"/>
          <a:ext cx="2438400" cy="33464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2437759" imgH="3346998" progId="Prism10.Document">
                  <p:embed/>
                </p:oleObj>
              </mc:Choice>
              <mc:Fallback>
                <p:oleObj name="Prism 10" r:id="rId2" imgW="2437759" imgH="3346998" progId="Prism10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F3D2422D-6617-02AB-E2A3-E808592BED7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366618" y="1611647"/>
                        <a:ext cx="2438400" cy="33464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45E6687B-3C12-E494-FB84-AEAE913A95C8}"/>
              </a:ext>
            </a:extLst>
          </p:cNvPr>
          <p:cNvGraphicFramePr>
            <a:graphicFrameLocks noChangeAspect="1"/>
          </p:cNvGraphicFramePr>
          <p:nvPr/>
        </p:nvGraphicFramePr>
        <p:xfrm>
          <a:off x="5066837" y="1582096"/>
          <a:ext cx="2397125" cy="3352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" imgW="2396703" imgH="3353119" progId="Prism10.Document">
                  <p:embed/>
                </p:oleObj>
              </mc:Choice>
              <mc:Fallback>
                <p:oleObj name="Prism 10" r:id="rId4" imgW="2396703" imgH="3353119" progId="Prism10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45E6687B-3C12-E494-FB84-AEAE913A95C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5066837" y="1582096"/>
                        <a:ext cx="2397125" cy="3352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6E706562-8A61-CE5A-63C8-420D9EB46A0C}"/>
              </a:ext>
            </a:extLst>
          </p:cNvPr>
          <p:cNvGraphicFramePr>
            <a:graphicFrameLocks noChangeAspect="1"/>
          </p:cNvGraphicFramePr>
          <p:nvPr/>
        </p:nvGraphicFramePr>
        <p:xfrm>
          <a:off x="7724577" y="1588628"/>
          <a:ext cx="2130425" cy="33401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6" imgW="2129843" imgH="3340877" progId="Prism10.Document">
                  <p:embed/>
                </p:oleObj>
              </mc:Choice>
              <mc:Fallback>
                <p:oleObj name="Prism 10" r:id="rId6" imgW="2129843" imgH="3340877" progId="Prism10.Document">
                  <p:embed/>
                  <p:pic>
                    <p:nvPicPr>
                      <p:cNvPr id="8" name="Object 7">
                        <a:extLst>
                          <a:ext uri="{FF2B5EF4-FFF2-40B4-BE49-F238E27FC236}">
                            <a16:creationId xmlns:a16="http://schemas.microsoft.com/office/drawing/2014/main" id="{6E706562-8A61-CE5A-63C8-420D9EB46A0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7724577" y="1588628"/>
                        <a:ext cx="2130425" cy="33401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9" name="TextBox 8">
            <a:extLst>
              <a:ext uri="{FF2B5EF4-FFF2-40B4-BE49-F238E27FC236}">
                <a16:creationId xmlns:a16="http://schemas.microsoft.com/office/drawing/2014/main" id="{40BEA43A-5902-555A-9AAA-670A43A735F0}"/>
              </a:ext>
            </a:extLst>
          </p:cNvPr>
          <p:cNvSpPr txBox="1"/>
          <p:nvPr/>
        </p:nvSpPr>
        <p:spPr>
          <a:xfrm>
            <a:off x="2521698" y="4988208"/>
            <a:ext cx="733330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S2. No difference in blood pressure and pulse wave velocity between WT and HDAC9 TG mice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Systolic blood pressure. (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Diastolic blood pressure. (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Pulse wave velocity.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620940C-C2A3-99BE-6CDB-D16217863565}"/>
              </a:ext>
            </a:extLst>
          </p:cNvPr>
          <p:cNvSpPr txBox="1"/>
          <p:nvPr/>
        </p:nvSpPr>
        <p:spPr>
          <a:xfrm>
            <a:off x="2257506" y="1307411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5C59A49-5991-6684-20BB-E11EDCA65C90}"/>
              </a:ext>
            </a:extLst>
          </p:cNvPr>
          <p:cNvSpPr txBox="1"/>
          <p:nvPr/>
        </p:nvSpPr>
        <p:spPr>
          <a:xfrm>
            <a:off x="4889944" y="1307411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75B3A7B-E2B7-EB26-45C4-38A6B1C5D937}"/>
              </a:ext>
            </a:extLst>
          </p:cNvPr>
          <p:cNvSpPr txBox="1"/>
          <p:nvPr/>
        </p:nvSpPr>
        <p:spPr>
          <a:xfrm>
            <a:off x="7724577" y="1307411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10985722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8FDFABA9-8F17-346D-DE48-6008DEA5E75C}"/>
              </a:ext>
            </a:extLst>
          </p:cNvPr>
          <p:cNvSpPr txBox="1"/>
          <p:nvPr/>
        </p:nvSpPr>
        <p:spPr>
          <a:xfrm>
            <a:off x="653890" y="469357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S3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0BEA43A-5902-555A-9AAA-670A43A735F0}"/>
              </a:ext>
            </a:extLst>
          </p:cNvPr>
          <p:cNvSpPr txBox="1"/>
          <p:nvPr/>
        </p:nvSpPr>
        <p:spPr>
          <a:xfrm>
            <a:off x="1460570" y="4794254"/>
            <a:ext cx="953767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S3. No difference in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adipogenic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gene expression between WT and HDAC9 TG mice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US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Ppar</a:t>
            </a:r>
            <a:r>
              <a:rPr lang="el-GR" sz="1200" i="1" dirty="0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(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C/</a:t>
            </a:r>
            <a:r>
              <a:rPr lang="en-US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ebp</a:t>
            </a:r>
            <a:r>
              <a:rPr lang="el-GR" sz="1200" i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(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Fabp4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(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Adiponectin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620940C-C2A3-99BE-6CDB-D16217863565}"/>
              </a:ext>
            </a:extLst>
          </p:cNvPr>
          <p:cNvSpPr txBox="1"/>
          <p:nvPr/>
        </p:nvSpPr>
        <p:spPr>
          <a:xfrm>
            <a:off x="1509885" y="167620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5C59A49-5991-6684-20BB-E11EDCA65C90}"/>
              </a:ext>
            </a:extLst>
          </p:cNvPr>
          <p:cNvSpPr txBox="1"/>
          <p:nvPr/>
        </p:nvSpPr>
        <p:spPr>
          <a:xfrm>
            <a:off x="3996375" y="167620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75B3A7B-E2B7-EB26-45C4-38A6B1C5D937}"/>
              </a:ext>
            </a:extLst>
          </p:cNvPr>
          <p:cNvSpPr txBox="1"/>
          <p:nvPr/>
        </p:nvSpPr>
        <p:spPr>
          <a:xfrm>
            <a:off x="6333339" y="167620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1740CD83-3373-9D4D-86AF-9B1C416C1AC5}"/>
              </a:ext>
            </a:extLst>
          </p:cNvPr>
          <p:cNvSpPr txBox="1"/>
          <p:nvPr/>
        </p:nvSpPr>
        <p:spPr>
          <a:xfrm>
            <a:off x="8693308" y="167620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graphicFrame>
        <p:nvGraphicFramePr>
          <p:cNvPr id="15" name="Object 14">
            <a:extLst>
              <a:ext uri="{FF2B5EF4-FFF2-40B4-BE49-F238E27FC236}">
                <a16:creationId xmlns:a16="http://schemas.microsoft.com/office/drawing/2014/main" id="{3A93F92C-8991-55DF-F584-7D93FAC37E73}"/>
              </a:ext>
            </a:extLst>
          </p:cNvPr>
          <p:cNvGraphicFramePr>
            <a:graphicFrameLocks noChangeAspect="1"/>
          </p:cNvGraphicFramePr>
          <p:nvPr/>
        </p:nvGraphicFramePr>
        <p:xfrm>
          <a:off x="9010650" y="1527175"/>
          <a:ext cx="1974850" cy="31892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1974264" imgH="3188577" progId="Prism10.Document">
                  <p:embed/>
                </p:oleObj>
              </mc:Choice>
              <mc:Fallback>
                <p:oleObj name="Prism 10" r:id="rId2" imgW="1974264" imgH="3188577" progId="Prism10.Document">
                  <p:embed/>
                  <p:pic>
                    <p:nvPicPr>
                      <p:cNvPr id="15" name="Object 14">
                        <a:extLst>
                          <a:ext uri="{FF2B5EF4-FFF2-40B4-BE49-F238E27FC236}">
                            <a16:creationId xmlns:a16="http://schemas.microsoft.com/office/drawing/2014/main" id="{3A93F92C-8991-55DF-F584-7D93FAC37E7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9010650" y="1527175"/>
                        <a:ext cx="1974850" cy="31892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Object 15">
            <a:extLst>
              <a:ext uri="{FF2B5EF4-FFF2-40B4-BE49-F238E27FC236}">
                <a16:creationId xmlns:a16="http://schemas.microsoft.com/office/drawing/2014/main" id="{1CB766F7-2D5F-17DD-E379-0EFF057C0D1C}"/>
              </a:ext>
            </a:extLst>
          </p:cNvPr>
          <p:cNvGraphicFramePr>
            <a:graphicFrameLocks noChangeAspect="1"/>
          </p:cNvGraphicFramePr>
          <p:nvPr/>
        </p:nvGraphicFramePr>
        <p:xfrm>
          <a:off x="1851025" y="1508125"/>
          <a:ext cx="1847850" cy="31892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" imgW="1847856" imgH="3188577" progId="Prism10.Document">
                  <p:embed/>
                </p:oleObj>
              </mc:Choice>
              <mc:Fallback>
                <p:oleObj name="Prism 10" r:id="rId4" imgW="1847856" imgH="3188577" progId="Prism10.Document">
                  <p:embed/>
                  <p:pic>
                    <p:nvPicPr>
                      <p:cNvPr id="16" name="Object 15">
                        <a:extLst>
                          <a:ext uri="{FF2B5EF4-FFF2-40B4-BE49-F238E27FC236}">
                            <a16:creationId xmlns:a16="http://schemas.microsoft.com/office/drawing/2014/main" id="{1CB766F7-2D5F-17DD-E379-0EFF057C0D1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851025" y="1508125"/>
                        <a:ext cx="1847850" cy="31892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" name="Object 16">
            <a:extLst>
              <a:ext uri="{FF2B5EF4-FFF2-40B4-BE49-F238E27FC236}">
                <a16:creationId xmlns:a16="http://schemas.microsoft.com/office/drawing/2014/main" id="{48AE30FC-B124-134C-610F-D7B02951FC08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257675" y="1490663"/>
          <a:ext cx="1968500" cy="31892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6" imgW="1968142" imgH="3188577" progId="Prism10.Document">
                  <p:embed/>
                </p:oleObj>
              </mc:Choice>
              <mc:Fallback>
                <p:oleObj name="Prism 10" r:id="rId6" imgW="1968142" imgH="3188577" progId="Prism10.Document">
                  <p:embed/>
                  <p:pic>
                    <p:nvPicPr>
                      <p:cNvPr id="17" name="Object 16">
                        <a:extLst>
                          <a:ext uri="{FF2B5EF4-FFF2-40B4-BE49-F238E27FC236}">
                            <a16:creationId xmlns:a16="http://schemas.microsoft.com/office/drawing/2014/main" id="{48AE30FC-B124-134C-610F-D7B02951FC0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4257675" y="1490663"/>
                        <a:ext cx="1968500" cy="31892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" name="Object 17">
            <a:extLst>
              <a:ext uri="{FF2B5EF4-FFF2-40B4-BE49-F238E27FC236}">
                <a16:creationId xmlns:a16="http://schemas.microsoft.com/office/drawing/2014/main" id="{FD5200F3-4113-3448-DA0E-0E58B0F29F11}"/>
              </a:ext>
            </a:extLst>
          </p:cNvPr>
          <p:cNvGraphicFramePr>
            <a:graphicFrameLocks noChangeAspect="1"/>
          </p:cNvGraphicFramePr>
          <p:nvPr/>
        </p:nvGraphicFramePr>
        <p:xfrm>
          <a:off x="6650038" y="1500188"/>
          <a:ext cx="1936750" cy="32067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8" imgW="1936090" imgH="3206940" progId="Prism10.Document">
                  <p:embed/>
                </p:oleObj>
              </mc:Choice>
              <mc:Fallback>
                <p:oleObj name="Prism 10" r:id="rId8" imgW="1936090" imgH="3206940" progId="Prism10.Document">
                  <p:embed/>
                  <p:pic>
                    <p:nvPicPr>
                      <p:cNvPr id="18" name="Object 17">
                        <a:extLst>
                          <a:ext uri="{FF2B5EF4-FFF2-40B4-BE49-F238E27FC236}">
                            <a16:creationId xmlns:a16="http://schemas.microsoft.com/office/drawing/2014/main" id="{FD5200F3-4113-3448-DA0E-0E58B0F29F1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6650038" y="1500188"/>
                        <a:ext cx="1936750" cy="32067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51312554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9376A9BB-C82D-CBB8-FCE1-86CF4361D79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26256310"/>
              </p:ext>
            </p:extLst>
          </p:nvPr>
        </p:nvGraphicFramePr>
        <p:xfrm>
          <a:off x="6304591" y="1662230"/>
          <a:ext cx="2381250" cy="38131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1991190" imgH="3188577" progId="Prism10.Document">
                  <p:embed/>
                </p:oleObj>
              </mc:Choice>
              <mc:Fallback>
                <p:oleObj name="Prism 10" r:id="rId2" imgW="1991190" imgH="3188577" progId="Prism10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9376A9BB-C82D-CBB8-FCE1-86CF4361D79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6304591" y="1662230"/>
                        <a:ext cx="2381250" cy="38131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737F10C5-F133-4ADE-3CE2-A291B5C152E3}"/>
              </a:ext>
            </a:extLst>
          </p:cNvPr>
          <p:cNvSpPr txBox="1"/>
          <p:nvPr/>
        </p:nvSpPr>
        <p:spPr>
          <a:xfrm>
            <a:off x="1266821" y="469357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S4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5205FD26-2E4B-5106-B6D6-CCD090A58E2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22576713"/>
              </p:ext>
            </p:extLst>
          </p:nvPr>
        </p:nvGraphicFramePr>
        <p:xfrm>
          <a:off x="2777498" y="1625960"/>
          <a:ext cx="2573890" cy="384944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" imgW="2180262" imgH="3261195" progId="Prism10.Document">
                  <p:embed/>
                </p:oleObj>
              </mc:Choice>
              <mc:Fallback>
                <p:oleObj name="Prism 10" r:id="rId4" imgW="2180262" imgH="3261195" progId="Prism10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E5BC822A-19F6-6E0E-4AF9-BEA824F9CD5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777498" y="1625960"/>
                        <a:ext cx="2573890" cy="384944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80E26334-024A-D049-FDBA-9FBA686F1703}"/>
              </a:ext>
            </a:extLst>
          </p:cNvPr>
          <p:cNvSpPr txBox="1"/>
          <p:nvPr/>
        </p:nvSpPr>
        <p:spPr>
          <a:xfrm>
            <a:off x="2497928" y="1658269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DBBB020-8883-139E-70DE-478B2845406D}"/>
              </a:ext>
            </a:extLst>
          </p:cNvPr>
          <p:cNvSpPr txBox="1"/>
          <p:nvPr/>
        </p:nvSpPr>
        <p:spPr>
          <a:xfrm>
            <a:off x="6128902" y="1658269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0A635E5F-0087-8875-2E36-A718340DBC52}"/>
              </a:ext>
            </a:extLst>
          </p:cNvPr>
          <p:cNvSpPr txBox="1"/>
          <p:nvPr/>
        </p:nvSpPr>
        <p:spPr>
          <a:xfrm>
            <a:off x="1699909" y="5684106"/>
            <a:ext cx="953767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S4. No difference in plasma cholesterol and insulin levels between WT and HDAC9 TG mice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plasma cholesterol. (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random (non-fasting) insulin.</a:t>
            </a:r>
          </a:p>
        </p:txBody>
      </p:sp>
    </p:spTree>
    <p:extLst>
      <p:ext uri="{BB962C8B-B14F-4D97-AF65-F5344CB8AC3E}">
        <p14:creationId xmlns:p14="http://schemas.microsoft.com/office/powerpoint/2010/main" val="157091745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28810DFA-2235-F803-08E9-DC32FBE0B3A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55916641"/>
              </p:ext>
            </p:extLst>
          </p:nvPr>
        </p:nvGraphicFramePr>
        <p:xfrm>
          <a:off x="3969039" y="1754188"/>
          <a:ext cx="1993900" cy="33305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1994071" imgH="3329984" progId="Prism10.Document">
                  <p:embed/>
                </p:oleObj>
              </mc:Choice>
              <mc:Fallback>
                <p:oleObj name="Prism 10" r:id="rId2" imgW="1994071" imgH="3329984" progId="Prism10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28810DFA-2235-F803-08E9-DC32FBE0B3A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969039" y="1754188"/>
                        <a:ext cx="1993900" cy="33305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6852E066-D294-8077-75CD-269CFEC2E16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37192002"/>
              </p:ext>
            </p:extLst>
          </p:nvPr>
        </p:nvGraphicFramePr>
        <p:xfrm>
          <a:off x="6470650" y="1754188"/>
          <a:ext cx="2005013" cy="33512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" imgW="2004876" imgH="3351233" progId="Prism10.Document">
                  <p:embed/>
                </p:oleObj>
              </mc:Choice>
              <mc:Fallback>
                <p:oleObj name="Prism 10" r:id="rId4" imgW="2004876" imgH="3351233" progId="Prism10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6852E066-D294-8077-75CD-269CFEC2E16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6470650" y="1754188"/>
                        <a:ext cx="2005013" cy="33512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02FDF77D-A942-E389-B295-326149C9F661}"/>
              </a:ext>
            </a:extLst>
          </p:cNvPr>
          <p:cNvSpPr txBox="1"/>
          <p:nvPr/>
        </p:nvSpPr>
        <p:spPr>
          <a:xfrm>
            <a:off x="2396773" y="827712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S5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81895DC6-8DA5-0F0D-897A-0ADB086AA624}"/>
              </a:ext>
            </a:extLst>
          </p:cNvPr>
          <p:cNvSpPr txBox="1"/>
          <p:nvPr/>
        </p:nvSpPr>
        <p:spPr>
          <a:xfrm>
            <a:off x="2810013" y="5199291"/>
            <a:ext cx="703290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S5. Expression of fatty acid oxidation-related genes in livers of WT and HDAC9 TG mice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Cact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(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Cpt1</a:t>
            </a:r>
            <a:r>
              <a:rPr lang="el-GR" sz="1200" i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89453213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4136752" y="897449"/>
            <a:ext cx="41729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Oil Red O Staining in skeletal muscles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4604323" y="1487429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6680076" y="1487429"/>
            <a:ext cx="13474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HDAC9 TG</a:t>
            </a:r>
          </a:p>
        </p:txBody>
      </p:sp>
      <p:graphicFrame>
        <p:nvGraphicFramePr>
          <p:cNvPr id="7" name="Objec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68007537"/>
              </p:ext>
            </p:extLst>
          </p:nvPr>
        </p:nvGraphicFramePr>
        <p:xfrm>
          <a:off x="3977668" y="1835729"/>
          <a:ext cx="1797050" cy="1346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Image" r:id="rId2" imgW="1797840" imgH="1346760" progId="Photoshop.Image.13">
                  <p:embed/>
                </p:oleObj>
              </mc:Choice>
              <mc:Fallback>
                <p:oleObj name="Image" r:id="rId2" imgW="1797840" imgH="1346760" progId="Photoshop.Image.13">
                  <p:embed/>
                  <p:pic>
                    <p:nvPicPr>
                      <p:cNvPr id="7" name="Object 6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977668" y="1835729"/>
                        <a:ext cx="1797050" cy="1346200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TextBox 7"/>
          <p:cNvSpPr txBox="1"/>
          <p:nvPr/>
        </p:nvSpPr>
        <p:spPr>
          <a:xfrm rot="16200000">
            <a:off x="3637013" y="2394656"/>
            <a:ext cx="4042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5X</a:t>
            </a:r>
          </a:p>
        </p:txBody>
      </p:sp>
      <p:sp>
        <p:nvSpPr>
          <p:cNvPr id="9" name="TextBox 8"/>
          <p:cNvSpPr txBox="1"/>
          <p:nvPr/>
        </p:nvSpPr>
        <p:spPr>
          <a:xfrm rot="16200000">
            <a:off x="3574056" y="3881399"/>
            <a:ext cx="5036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10X</a:t>
            </a:r>
          </a:p>
        </p:txBody>
      </p:sp>
      <p:sp>
        <p:nvSpPr>
          <p:cNvPr id="10" name="TextBox 9"/>
          <p:cNvSpPr txBox="1"/>
          <p:nvPr/>
        </p:nvSpPr>
        <p:spPr>
          <a:xfrm rot="16200000">
            <a:off x="3587320" y="5337486"/>
            <a:ext cx="5036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40X</a:t>
            </a:r>
          </a:p>
        </p:txBody>
      </p:sp>
      <p:graphicFrame>
        <p:nvGraphicFramePr>
          <p:cNvPr id="14" name="Object 1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15309020"/>
              </p:ext>
            </p:extLst>
          </p:nvPr>
        </p:nvGraphicFramePr>
        <p:xfrm>
          <a:off x="3977668" y="3303221"/>
          <a:ext cx="1797050" cy="1346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Image" r:id="rId4" imgW="1797840" imgH="1346760" progId="Photoshop.Image.13">
                  <p:embed/>
                </p:oleObj>
              </mc:Choice>
              <mc:Fallback>
                <p:oleObj name="Image" r:id="rId4" imgW="1797840" imgH="1346760" progId="Photoshop.Image.13">
                  <p:embed/>
                  <p:pic>
                    <p:nvPicPr>
                      <p:cNvPr id="14" name="Object 13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977668" y="3303221"/>
                        <a:ext cx="1797050" cy="1346200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Object 1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33607283"/>
              </p:ext>
            </p:extLst>
          </p:nvPr>
        </p:nvGraphicFramePr>
        <p:xfrm>
          <a:off x="3977668" y="4770713"/>
          <a:ext cx="1797050" cy="1346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Image" r:id="rId6" imgW="1797840" imgH="1346760" progId="Photoshop.Image.13">
                  <p:embed/>
                </p:oleObj>
              </mc:Choice>
              <mc:Fallback>
                <p:oleObj name="Image" r:id="rId6" imgW="1797840" imgH="1346760" progId="Photoshop.Image.13">
                  <p:embed/>
                  <p:pic>
                    <p:nvPicPr>
                      <p:cNvPr id="15" name="Object 14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3977668" y="4770713"/>
                        <a:ext cx="1797050" cy="1346200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Object 1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59154937"/>
              </p:ext>
            </p:extLst>
          </p:nvPr>
        </p:nvGraphicFramePr>
        <p:xfrm>
          <a:off x="6455293" y="1826800"/>
          <a:ext cx="1797050" cy="1346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Image" r:id="rId8" imgW="1797840" imgH="1346760" progId="Photoshop.Image.13">
                  <p:embed/>
                </p:oleObj>
              </mc:Choice>
              <mc:Fallback>
                <p:oleObj name="Image" r:id="rId8" imgW="1797840" imgH="1346760" progId="Photoshop.Image.13">
                  <p:embed/>
                  <p:pic>
                    <p:nvPicPr>
                      <p:cNvPr id="16" name="Object 15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6455293" y="1826800"/>
                        <a:ext cx="1797050" cy="1346200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" name="Object 1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36612386"/>
              </p:ext>
            </p:extLst>
          </p:nvPr>
        </p:nvGraphicFramePr>
        <p:xfrm>
          <a:off x="6455293" y="3307300"/>
          <a:ext cx="1797050" cy="1346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Image" r:id="rId10" imgW="1797840" imgH="1346760" progId="Photoshop.Image.13">
                  <p:embed/>
                </p:oleObj>
              </mc:Choice>
              <mc:Fallback>
                <p:oleObj name="Image" r:id="rId10" imgW="1797840" imgH="1346760" progId="Photoshop.Image.13">
                  <p:embed/>
                  <p:pic>
                    <p:nvPicPr>
                      <p:cNvPr id="17" name="Object 16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6455293" y="3307300"/>
                        <a:ext cx="1797050" cy="1346200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" name="Object 1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86896760"/>
              </p:ext>
            </p:extLst>
          </p:nvPr>
        </p:nvGraphicFramePr>
        <p:xfrm>
          <a:off x="6455293" y="4787800"/>
          <a:ext cx="1797050" cy="1346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Image" r:id="rId12" imgW="1797840" imgH="1346760" progId="Photoshop.Image.13">
                  <p:embed/>
                </p:oleObj>
              </mc:Choice>
              <mc:Fallback>
                <p:oleObj name="Image" r:id="rId12" imgW="1797840" imgH="1346760" progId="Photoshop.Image.13">
                  <p:embed/>
                  <p:pic>
                    <p:nvPicPr>
                      <p:cNvPr id="18" name="Object 17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6455293" y="4787800"/>
                        <a:ext cx="1797050" cy="1346200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19" name="TextBox 18">
            <a:extLst>
              <a:ext uri="{FF2B5EF4-FFF2-40B4-BE49-F238E27FC236}">
                <a16:creationId xmlns:a16="http://schemas.microsoft.com/office/drawing/2014/main" id="{43F4713E-F1FF-E7A4-E884-4EF7168EAD15}"/>
              </a:ext>
            </a:extLst>
          </p:cNvPr>
          <p:cNvSpPr txBox="1"/>
          <p:nvPr/>
        </p:nvSpPr>
        <p:spPr>
          <a:xfrm>
            <a:off x="1164077" y="415401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S6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27AA097C-93D1-F9D0-10B2-0E04B6C05F29}"/>
              </a:ext>
            </a:extLst>
          </p:cNvPr>
          <p:cNvSpPr txBox="1"/>
          <p:nvPr/>
        </p:nvSpPr>
        <p:spPr>
          <a:xfrm rot="16200000">
            <a:off x="6131393" y="2402594"/>
            <a:ext cx="4042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5X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F7A73EC4-4A97-8BF7-D954-D3297E890B87}"/>
              </a:ext>
            </a:extLst>
          </p:cNvPr>
          <p:cNvSpPr txBox="1"/>
          <p:nvPr/>
        </p:nvSpPr>
        <p:spPr>
          <a:xfrm rot="16200000">
            <a:off x="6068436" y="3889337"/>
            <a:ext cx="5036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10X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7E2F10C4-AE35-7B09-287A-137EFC62D778}"/>
              </a:ext>
            </a:extLst>
          </p:cNvPr>
          <p:cNvSpPr txBox="1"/>
          <p:nvPr/>
        </p:nvSpPr>
        <p:spPr>
          <a:xfrm rot="16200000">
            <a:off x="6081700" y="5345424"/>
            <a:ext cx="5036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40X</a:t>
            </a:r>
          </a:p>
        </p:txBody>
      </p:sp>
    </p:spTree>
    <p:extLst>
      <p:ext uri="{BB962C8B-B14F-4D97-AF65-F5344CB8AC3E}">
        <p14:creationId xmlns:p14="http://schemas.microsoft.com/office/powerpoint/2010/main" val="289020124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E0F92AD6-BD0F-CD21-8D01-6D015BF5A7A7}"/>
              </a:ext>
            </a:extLst>
          </p:cNvPr>
          <p:cNvGraphicFramePr>
            <a:graphicFrameLocks noGrp="1"/>
          </p:cNvGraphicFramePr>
          <p:nvPr/>
        </p:nvGraphicFramePr>
        <p:xfrm>
          <a:off x="1568407" y="1184748"/>
          <a:ext cx="9416191" cy="2658179"/>
        </p:xfrm>
        <a:graphic>
          <a:graphicData uri="http://schemas.openxmlformats.org/drawingml/2006/table">
            <a:tbl>
              <a:tblPr firstRow="1" firstCol="1" bandRow="1">
                <a:tableStyleId>{F5AB1C69-6EDB-4FF4-983F-18BD219EF322}</a:tableStyleId>
              </a:tblPr>
              <a:tblGrid>
                <a:gridCol w="3138059">
                  <a:extLst>
                    <a:ext uri="{9D8B030D-6E8A-4147-A177-3AD203B41FA5}">
                      <a16:colId xmlns:a16="http://schemas.microsoft.com/office/drawing/2014/main" val="2190355104"/>
                    </a:ext>
                  </a:extLst>
                </a:gridCol>
                <a:gridCol w="3139066">
                  <a:extLst>
                    <a:ext uri="{9D8B030D-6E8A-4147-A177-3AD203B41FA5}">
                      <a16:colId xmlns:a16="http://schemas.microsoft.com/office/drawing/2014/main" val="2097599797"/>
                    </a:ext>
                  </a:extLst>
                </a:gridCol>
                <a:gridCol w="3139066">
                  <a:extLst>
                    <a:ext uri="{9D8B030D-6E8A-4147-A177-3AD203B41FA5}">
                      <a16:colId xmlns:a16="http://schemas.microsoft.com/office/drawing/2014/main" val="199701931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</a:rPr>
                        <a:t>Gene Name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</a:rPr>
                        <a:t>Forward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</a:rPr>
                        <a:t>Reverse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90515738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</a:rPr>
                        <a:t>HDAC9 transgene (352 bp, for genotyping)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</a:rPr>
                        <a:t>TCCACCAGTCCGTGAATACGA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</a:rPr>
                        <a:t>GATCTCAGTGGTATTTGTGAGCCAG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65993513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</a:rPr>
                        <a:t>HDAC9 transgene (511 bp, for genotyping)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</a:rPr>
                        <a:t>GCCTTTTATGGTAATCGTGCGAG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</a:rPr>
                        <a:t>TCTGATTTCACGTCCACTGAGC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69063592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diponectin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CACTGGCAAGTTCTACTGCAACA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GAGAACGGCCTTGTCCTTCTTGA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0118135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rbp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GCTGAAGCAAAGAAAGAGTCGGA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CTTGGTGGCTTTGGCGGGATTAG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13967368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/</a:t>
                      </a:r>
                      <a:r>
                        <a:rPr lang="en-US" sz="12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ebp</a:t>
                      </a: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α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GAAGTCGGTGGACAAGAACAGCA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GCTTGTTTGGCTTTATCTCGGCT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9642022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Fabp4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TGAAATGACCGCAGACGACGGA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GTGGTCGACCTTCCATCCCACTT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9186826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Hdac9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GGATGATGATGCCTGTGGTGGAT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AGTTGTGCTTGATGCTACCTTGT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23109002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par</a:t>
                      </a:r>
                      <a:r>
                        <a:rPr lang="el-GR" sz="12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γ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CATAAAGTCCTTCCCGCTGACCA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AATTCTGGCCACCTCTTTGC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54389786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act 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TGGACACTGTTGCTGAGAGG</a:t>
                      </a:r>
                      <a:endParaRPr lang="en-US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TTGGCCAAAGGTATCGAGTC</a:t>
                      </a:r>
                      <a:endParaRPr lang="en-US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83976282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i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t1</a:t>
                      </a:r>
                      <a:r>
                        <a:rPr lang="el-GR" sz="1200" b="1" i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α</a:t>
                      </a:r>
                      <a:endParaRPr lang="en-US" sz="1200" b="1" i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GGGCTACTCAGAGGATGGAC</a:t>
                      </a:r>
                      <a:endParaRPr lang="en-US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GGAATGTCCCACTGTAGCCT</a:t>
                      </a:r>
                      <a:endParaRPr lang="en-US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914224336"/>
                  </a:ext>
                </a:extLst>
              </a:tr>
            </a:tbl>
          </a:graphicData>
        </a:graphic>
      </p:graphicFrame>
      <p:sp>
        <p:nvSpPr>
          <p:cNvPr id="3" name="Rectangle 1">
            <a:extLst>
              <a:ext uri="{FF2B5EF4-FFF2-40B4-BE49-F238E27FC236}">
                <a16:creationId xmlns:a16="http://schemas.microsoft.com/office/drawing/2014/main" id="{837CB0AD-C408-A857-7756-C888CFD035F4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68407" y="830151"/>
            <a:ext cx="5937250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l Table </a:t>
            </a:r>
            <a:r>
              <a:rPr lang="en-US" altLang="en-US" sz="14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</a:t>
            </a:r>
            <a:r>
              <a:rPr kumimoji="0" lang="en-US" altLang="en-US" sz="14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</a:t>
            </a:r>
            <a:r>
              <a:rPr kumimoji="0" lang="en-US" altLang="en-US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: Primer Sequences. </a:t>
            </a:r>
            <a:endParaRPr kumimoji="0" lang="en-US" altLang="en-US" sz="2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7350076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689B5601-0460-62EB-89B9-CE6D21CE28D2}"/>
              </a:ext>
            </a:extLst>
          </p:cNvPr>
          <p:cNvSpPr txBox="1"/>
          <p:nvPr/>
        </p:nvSpPr>
        <p:spPr>
          <a:xfrm>
            <a:off x="8200501" y="2568582"/>
            <a:ext cx="812121" cy="261609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1050" b="1" dirty="0">
                <a:latin typeface="Arial"/>
                <a:ea typeface="Calibri"/>
                <a:cs typeface="Arial"/>
              </a:rPr>
              <a:t>150 kDa</a:t>
            </a:r>
            <a:endParaRPr lang="en-US" sz="1050" b="1" dirty="0">
              <a:ea typeface="Calibri"/>
              <a:cs typeface="Calibri"/>
            </a:endParaRPr>
          </a:p>
        </p:txBody>
      </p:sp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id="{7AD9E4A9-CB86-4A52-F915-05D686A7210E}"/>
              </a:ext>
            </a:extLst>
          </p:cNvPr>
          <p:cNvCxnSpPr>
            <a:cxnSpLocks/>
          </p:cNvCxnSpPr>
          <p:nvPr/>
        </p:nvCxnSpPr>
        <p:spPr>
          <a:xfrm>
            <a:off x="7678496" y="5289176"/>
            <a:ext cx="179591" cy="235"/>
          </a:xfrm>
          <a:prstGeom prst="straightConnector1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" name="TextBox 6">
            <a:extLst>
              <a:ext uri="{FF2B5EF4-FFF2-40B4-BE49-F238E27FC236}">
                <a16:creationId xmlns:a16="http://schemas.microsoft.com/office/drawing/2014/main" id="{4676EAC6-5452-AB30-6C18-F84B6CDEC6D3}"/>
              </a:ext>
            </a:extLst>
          </p:cNvPr>
          <p:cNvSpPr txBox="1"/>
          <p:nvPr/>
        </p:nvSpPr>
        <p:spPr>
          <a:xfrm>
            <a:off x="7794440" y="5153966"/>
            <a:ext cx="812121" cy="261609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1050" b="1" dirty="0">
                <a:latin typeface="Arial"/>
                <a:ea typeface="Calibri"/>
                <a:cs typeface="Arial"/>
              </a:rPr>
              <a:t>75 kD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FE908D9-8E67-4A5E-1DEA-B55F06F5AD31}"/>
              </a:ext>
            </a:extLst>
          </p:cNvPr>
          <p:cNvSpPr txBox="1"/>
          <p:nvPr/>
        </p:nvSpPr>
        <p:spPr>
          <a:xfrm rot="18980861">
            <a:off x="4294572" y="1905659"/>
            <a:ext cx="385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78DD5C3-2506-78A7-FCD0-F67612A09702}"/>
              </a:ext>
            </a:extLst>
          </p:cNvPr>
          <p:cNvSpPr txBox="1"/>
          <p:nvPr/>
        </p:nvSpPr>
        <p:spPr>
          <a:xfrm rot="18980861">
            <a:off x="4027917" y="1905659"/>
            <a:ext cx="3626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TG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1BCE3D6-F48E-5354-07FD-9EC15BDE18CD}"/>
              </a:ext>
            </a:extLst>
          </p:cNvPr>
          <p:cNvSpPr txBox="1"/>
          <p:nvPr/>
        </p:nvSpPr>
        <p:spPr>
          <a:xfrm rot="18980861">
            <a:off x="4793759" y="1905659"/>
            <a:ext cx="385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6115D4B-397D-FD95-9E8E-7F0171660FFC}"/>
              </a:ext>
            </a:extLst>
          </p:cNvPr>
          <p:cNvSpPr txBox="1"/>
          <p:nvPr/>
        </p:nvSpPr>
        <p:spPr>
          <a:xfrm rot="18980861">
            <a:off x="4532786" y="1905659"/>
            <a:ext cx="3626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TG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23071756-B3FD-7448-5604-EA47CD2CE6EA}"/>
              </a:ext>
            </a:extLst>
          </p:cNvPr>
          <p:cNvSpPr txBox="1"/>
          <p:nvPr/>
        </p:nvSpPr>
        <p:spPr>
          <a:xfrm rot="18980861">
            <a:off x="5355404" y="1903207"/>
            <a:ext cx="385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FD83066B-23E5-415B-0AA2-04E7AD91C6FE}"/>
              </a:ext>
            </a:extLst>
          </p:cNvPr>
          <p:cNvSpPr txBox="1"/>
          <p:nvPr/>
        </p:nvSpPr>
        <p:spPr>
          <a:xfrm rot="18980861">
            <a:off x="5088749" y="1903208"/>
            <a:ext cx="3626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TG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FC3EA4A4-7A22-70C2-6241-5BD77D7A5DA1}"/>
              </a:ext>
            </a:extLst>
          </p:cNvPr>
          <p:cNvSpPr txBox="1"/>
          <p:nvPr/>
        </p:nvSpPr>
        <p:spPr>
          <a:xfrm rot="18980861">
            <a:off x="5929732" y="1903208"/>
            <a:ext cx="385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53CC2A46-F61F-0F78-32BD-57E38E01074E}"/>
              </a:ext>
            </a:extLst>
          </p:cNvPr>
          <p:cNvSpPr txBox="1"/>
          <p:nvPr/>
        </p:nvSpPr>
        <p:spPr>
          <a:xfrm rot="18980861">
            <a:off x="5678818" y="1903208"/>
            <a:ext cx="3626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TG</a:t>
            </a:r>
          </a:p>
        </p:txBody>
      </p: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BF0AE887-1553-1EBE-20F4-79AABE7F5A6C}"/>
              </a:ext>
            </a:extLst>
          </p:cNvPr>
          <p:cNvCxnSpPr>
            <a:cxnSpLocks/>
          </p:cNvCxnSpPr>
          <p:nvPr/>
        </p:nvCxnSpPr>
        <p:spPr>
          <a:xfrm>
            <a:off x="8099701" y="2703747"/>
            <a:ext cx="179591" cy="235"/>
          </a:xfrm>
          <a:prstGeom prst="straightConnector1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" name="TextBox 16">
            <a:extLst>
              <a:ext uri="{FF2B5EF4-FFF2-40B4-BE49-F238E27FC236}">
                <a16:creationId xmlns:a16="http://schemas.microsoft.com/office/drawing/2014/main" id="{7CF6CE4E-30BB-969F-3E73-D0506C4C8934}"/>
              </a:ext>
            </a:extLst>
          </p:cNvPr>
          <p:cNvSpPr txBox="1"/>
          <p:nvPr/>
        </p:nvSpPr>
        <p:spPr>
          <a:xfrm rot="18980861">
            <a:off x="6430913" y="1901888"/>
            <a:ext cx="385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0AEBCF89-A946-CB3A-9E32-B49A08009519}"/>
              </a:ext>
            </a:extLst>
          </p:cNvPr>
          <p:cNvSpPr txBox="1"/>
          <p:nvPr/>
        </p:nvSpPr>
        <p:spPr>
          <a:xfrm rot="18980861">
            <a:off x="6175618" y="1901888"/>
            <a:ext cx="3626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TG</a:t>
            </a:r>
          </a:p>
        </p:txBody>
      </p:sp>
      <p:pic>
        <p:nvPicPr>
          <p:cNvPr id="20" name="Content Placeholder 3" descr="A close-up of a black and white photo&#10;&#10;Description automatically generated">
            <a:extLst>
              <a:ext uri="{FF2B5EF4-FFF2-40B4-BE49-F238E27FC236}">
                <a16:creationId xmlns:a16="http://schemas.microsoft.com/office/drawing/2014/main" id="{D1AAEF27-D342-924B-6FE0-D892728E0AD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10" t="995" r="1130" b="4788"/>
          <a:stretch/>
        </p:blipFill>
        <p:spPr>
          <a:xfrm>
            <a:off x="3750976" y="2169669"/>
            <a:ext cx="4319148" cy="1973842"/>
          </a:xfrm>
          <a:prstGeom prst="rect">
            <a:avLst/>
          </a:prstGeom>
        </p:spPr>
      </p:pic>
      <p:pic>
        <p:nvPicPr>
          <p:cNvPr id="21" name="Picture 20" descr="A close-up of a test tube&#10;&#10;Description automatically generated">
            <a:extLst>
              <a:ext uri="{FF2B5EF4-FFF2-40B4-BE49-F238E27FC236}">
                <a16:creationId xmlns:a16="http://schemas.microsoft.com/office/drawing/2014/main" id="{E43D4FA1-0699-C777-7ECE-E8A527D1B398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827" t="3813" r="4715" b="11211"/>
          <a:stretch/>
        </p:blipFill>
        <p:spPr>
          <a:xfrm>
            <a:off x="3993058" y="4792186"/>
            <a:ext cx="3676517" cy="842091"/>
          </a:xfrm>
          <a:prstGeom prst="rect">
            <a:avLst/>
          </a:prstGeom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44EC55A4-55B3-F74B-7660-CB2D79E09AEB}"/>
              </a:ext>
            </a:extLst>
          </p:cNvPr>
          <p:cNvSpPr txBox="1"/>
          <p:nvPr/>
        </p:nvSpPr>
        <p:spPr>
          <a:xfrm>
            <a:off x="2938856" y="2665911"/>
            <a:ext cx="812120" cy="261610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r"/>
            <a:r>
              <a:rPr lang="en-US" sz="1100" b="1" dirty="0">
                <a:latin typeface="Arial"/>
                <a:ea typeface="Calibri"/>
                <a:cs typeface="Arial"/>
              </a:rPr>
              <a:t>HDAC9</a:t>
            </a:r>
            <a:endParaRPr lang="en-US" sz="1100" b="1" dirty="0">
              <a:latin typeface="Arial"/>
              <a:cs typeface="Arial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C325DD65-A3B8-97D2-2E59-3A32064CFC7A}"/>
              </a:ext>
            </a:extLst>
          </p:cNvPr>
          <p:cNvSpPr txBox="1"/>
          <p:nvPr/>
        </p:nvSpPr>
        <p:spPr>
          <a:xfrm>
            <a:off x="2988909" y="5153965"/>
            <a:ext cx="812120" cy="261610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r"/>
            <a:r>
              <a:rPr lang="en-US" sz="1100" b="1" dirty="0">
                <a:latin typeface="Arial"/>
                <a:ea typeface="Calibri"/>
                <a:cs typeface="Arial"/>
              </a:rPr>
              <a:t>Hsp90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9E86EF39-A2AB-6294-3BB3-606DE82DE64D}"/>
              </a:ext>
            </a:extLst>
          </p:cNvPr>
          <p:cNvSpPr txBox="1"/>
          <p:nvPr/>
        </p:nvSpPr>
        <p:spPr>
          <a:xfrm>
            <a:off x="2850501" y="801103"/>
            <a:ext cx="609494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Uncropped Western blot images (Figure 1E)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0E5B3BB5-04CB-F5C7-1416-74C49099E426}"/>
              </a:ext>
            </a:extLst>
          </p:cNvPr>
          <p:cNvSpPr/>
          <p:nvPr/>
        </p:nvSpPr>
        <p:spPr>
          <a:xfrm>
            <a:off x="3980410" y="2705265"/>
            <a:ext cx="2867302" cy="22225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681DD682-7AE5-3DBF-3674-FD76DBF0F530}"/>
              </a:ext>
            </a:extLst>
          </p:cNvPr>
          <p:cNvSpPr/>
          <p:nvPr/>
        </p:nvSpPr>
        <p:spPr>
          <a:xfrm>
            <a:off x="4114273" y="5003657"/>
            <a:ext cx="2874231" cy="32070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43732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865</TotalTime>
  <Words>276</Words>
  <Application>Microsoft Office PowerPoint</Application>
  <PresentationFormat>Widescreen</PresentationFormat>
  <Paragraphs>78</Paragraphs>
  <Slides>9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9</vt:i4>
      </vt:variant>
    </vt:vector>
  </HeadingPairs>
  <TitlesOfParts>
    <vt:vector size="15" baseType="lpstr">
      <vt:lpstr>Arial</vt:lpstr>
      <vt:lpstr>Calibri</vt:lpstr>
      <vt:lpstr>Calibri Light</vt:lpstr>
      <vt:lpstr>Office Theme</vt:lpstr>
      <vt:lpstr>Image</vt:lpstr>
      <vt:lpstr>Prism 10</vt:lpstr>
      <vt:lpstr>Supplementary Materials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l</dc:title>
  <dc:creator>Kim, Ha W.</dc:creator>
  <cp:lastModifiedBy>Ha Won Kim</cp:lastModifiedBy>
  <cp:revision>15</cp:revision>
  <dcterms:created xsi:type="dcterms:W3CDTF">2024-02-12T20:10:57Z</dcterms:created>
  <dcterms:modified xsi:type="dcterms:W3CDTF">2024-04-17T17:46:34Z</dcterms:modified>
</cp:coreProperties>
</file>